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6" Type="http://schemas.microsoft.com/office/2020/02/relationships/classificationlabels" Target="docMetadata/LabelInfo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7"/>
  </p:notesMasterIdLst>
  <p:sldIdLst>
    <p:sldId id="256" r:id="rId5"/>
    <p:sldId id="257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693B0F25-A4E8-3CFC-8B7B-A5D115F95921}" name="Denise Williams" initials="DW" userId="S::DWilliam@smithbucklin.com::dc19126e-9e19-4a8a-bbc1-b59efc4cf638" providerId="AD"/>
  <p188:author id="{E357C639-C27B-AC87-B51D-46B136696C35}" name="Melissa Glasner" initials="MG" userId="S::mglasner@smithbucklin.com::1f068961-5534-4ae7-b0aa-012b7ca9fbe6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998" autoAdjust="0"/>
    <p:restoredTop sz="94660"/>
  </p:normalViewPr>
  <p:slideViewPr>
    <p:cSldViewPr snapToGrid="0">
      <p:cViewPr varScale="1">
        <p:scale>
          <a:sx n="101" d="100"/>
          <a:sy n="101" d="100"/>
        </p:scale>
        <p:origin x="126" y="18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13" Type="http://schemas.microsoft.com/office/2018/10/relationships/authors" Target="authors.xml"/><Relationship Id="rId3" Type="http://schemas.openxmlformats.org/officeDocument/2006/relationships/customXml" Target="../customXml/item3.xml"/><Relationship Id="rId7" Type="http://schemas.openxmlformats.org/officeDocument/2006/relationships/notesMaster" Target="notesMasters/notesMaster1.xml"/><Relationship Id="rId12" Type="http://schemas.microsoft.com/office/2016/11/relationships/changesInfo" Target="changesInfos/changesInfo1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tableStyles" Target="tableStyles.xml"/><Relationship Id="rId5" Type="http://schemas.openxmlformats.org/officeDocument/2006/relationships/slide" Target="slides/slide1.xml"/><Relationship Id="rId10" Type="http://schemas.openxmlformats.org/officeDocument/2006/relationships/theme" Target="theme/theme1.xml"/><Relationship Id="rId4" Type="http://schemas.openxmlformats.org/officeDocument/2006/relationships/slideMaster" Target="slideMasters/slideMaster1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iriam Giles" userId="31426698-9c95-4506-a0c2-422bb13f8df4" providerId="ADAL" clId="{2E15971A-EE75-474C-A8D6-290A6CADF7DC}"/>
    <pc:docChg chg="modSld">
      <pc:chgData name="Miriam Giles" userId="31426698-9c95-4506-a0c2-422bb13f8df4" providerId="ADAL" clId="{2E15971A-EE75-474C-A8D6-290A6CADF7DC}" dt="2025-02-21T21:57:38.732" v="57" actId="1076"/>
      <pc:docMkLst>
        <pc:docMk/>
      </pc:docMkLst>
      <pc:sldChg chg="modSp mod">
        <pc:chgData name="Miriam Giles" userId="31426698-9c95-4506-a0c2-422bb13f8df4" providerId="ADAL" clId="{2E15971A-EE75-474C-A8D6-290A6CADF7DC}" dt="2025-02-21T21:57:38.732" v="57" actId="1076"/>
        <pc:sldMkLst>
          <pc:docMk/>
          <pc:sldMk cId="2752469878" sldId="257"/>
        </pc:sldMkLst>
      </pc:sldChg>
    </pc:docChg>
  </pc:docChgLst>
  <pc:docChgLst>
    <pc:chgData name="Miriam Giles" userId="31426698-9c95-4506-a0c2-422bb13f8df4" providerId="ADAL" clId="{548C4FF4-20F3-4A21-AD25-38A0D379129B}"/>
    <pc:docChg chg="undo custSel modSld">
      <pc:chgData name="Miriam Giles" userId="31426698-9c95-4506-a0c2-422bb13f8df4" providerId="ADAL" clId="{548C4FF4-20F3-4A21-AD25-38A0D379129B}" dt="2025-05-28T18:49:44.160" v="2" actId="6549"/>
      <pc:docMkLst>
        <pc:docMk/>
      </pc:docMkLst>
      <pc:sldChg chg="modSp mod">
        <pc:chgData name="Miriam Giles" userId="31426698-9c95-4506-a0c2-422bb13f8df4" providerId="ADAL" clId="{548C4FF4-20F3-4A21-AD25-38A0D379129B}" dt="2025-05-28T18:49:44.160" v="2" actId="6549"/>
        <pc:sldMkLst>
          <pc:docMk/>
          <pc:sldMk cId="3674515320" sldId="256"/>
        </pc:sldMkLst>
        <pc:spChg chg="mod">
          <ac:chgData name="Miriam Giles" userId="31426698-9c95-4506-a0c2-422bb13f8df4" providerId="ADAL" clId="{548C4FF4-20F3-4A21-AD25-38A0D379129B}" dt="2025-05-28T18:49:44.160" v="2" actId="6549"/>
          <ac:spMkLst>
            <pc:docMk/>
            <pc:sldMk cId="3674515320" sldId="256"/>
            <ac:spMk id="2" creationId="{90C88D0A-E0AD-3009-B3F7-996A7F99C013}"/>
          </ac:spMkLst>
        </pc:spChg>
      </pc:sldChg>
    </pc:docChg>
  </pc:docChgLst>
  <pc:docChgLst>
    <pc:chgData name="Melissa Glasner" userId="1f068961-5534-4ae7-b0aa-012b7ca9fbe6" providerId="ADAL" clId="{2CAF1248-905D-42D0-924E-8B40594556F0}"/>
    <pc:docChg chg="undo custSel modSld">
      <pc:chgData name="Melissa Glasner" userId="1f068961-5534-4ae7-b0aa-012b7ca9fbe6" providerId="ADAL" clId="{2CAF1248-905D-42D0-924E-8B40594556F0}" dt="2025-07-08T16:47:40.797" v="135" actId="1076"/>
      <pc:docMkLst>
        <pc:docMk/>
      </pc:docMkLst>
      <pc:sldChg chg="addSp delSp modSp mod">
        <pc:chgData name="Melissa Glasner" userId="1f068961-5534-4ae7-b0aa-012b7ca9fbe6" providerId="ADAL" clId="{2CAF1248-905D-42D0-924E-8B40594556F0}" dt="2025-07-08T16:47:40.797" v="135" actId="1076"/>
        <pc:sldMkLst>
          <pc:docMk/>
          <pc:sldMk cId="2752469878" sldId="257"/>
        </pc:sldMkLst>
        <pc:spChg chg="mod">
          <ac:chgData name="Melissa Glasner" userId="1f068961-5534-4ae7-b0aa-012b7ca9fbe6" providerId="ADAL" clId="{2CAF1248-905D-42D0-924E-8B40594556F0}" dt="2025-07-08T16:47:12.787" v="119" actId="403"/>
          <ac:spMkLst>
            <pc:docMk/>
            <pc:sldMk cId="2752469878" sldId="257"/>
            <ac:spMk id="4" creationId="{D863ACDF-6E65-5476-F731-2EC3AC183BE1}"/>
          </ac:spMkLst>
        </pc:spChg>
        <pc:spChg chg="mod">
          <ac:chgData name="Melissa Glasner" userId="1f068961-5534-4ae7-b0aa-012b7ca9fbe6" providerId="ADAL" clId="{2CAF1248-905D-42D0-924E-8B40594556F0}" dt="2025-07-08T16:46:25.386" v="110" actId="13822"/>
          <ac:spMkLst>
            <pc:docMk/>
            <pc:sldMk cId="2752469878" sldId="257"/>
            <ac:spMk id="5" creationId="{5FDB41C1-F0CD-4130-6878-D2EF4074BAE7}"/>
          </ac:spMkLst>
        </pc:spChg>
        <pc:spChg chg="add mod">
          <ac:chgData name="Melissa Glasner" userId="1f068961-5534-4ae7-b0aa-012b7ca9fbe6" providerId="ADAL" clId="{2CAF1248-905D-42D0-924E-8B40594556F0}" dt="2025-07-08T16:42:31.529" v="39" actId="113"/>
          <ac:spMkLst>
            <pc:docMk/>
            <pc:sldMk cId="2752469878" sldId="257"/>
            <ac:spMk id="6" creationId="{7019A228-BBA8-39DB-7963-ADE231813C7E}"/>
          </ac:spMkLst>
        </pc:spChg>
        <pc:spChg chg="mod">
          <ac:chgData name="Melissa Glasner" userId="1f068961-5534-4ae7-b0aa-012b7ca9fbe6" providerId="ADAL" clId="{2CAF1248-905D-42D0-924E-8B40594556F0}" dt="2025-07-08T16:42:09.938" v="32" actId="1076"/>
          <ac:spMkLst>
            <pc:docMk/>
            <pc:sldMk cId="2752469878" sldId="257"/>
            <ac:spMk id="11" creationId="{529C8760-3EC7-FE22-C313-D5996586070C}"/>
          </ac:spMkLst>
        </pc:spChg>
        <pc:spChg chg="mod">
          <ac:chgData name="Melissa Glasner" userId="1f068961-5534-4ae7-b0aa-012b7ca9fbe6" providerId="ADAL" clId="{2CAF1248-905D-42D0-924E-8B40594556F0}" dt="2025-07-08T16:42:20.208" v="36" actId="1076"/>
          <ac:spMkLst>
            <pc:docMk/>
            <pc:sldMk cId="2752469878" sldId="257"/>
            <ac:spMk id="12" creationId="{69832965-B6BA-5212-02D8-9010C937C06B}"/>
          </ac:spMkLst>
        </pc:spChg>
        <pc:spChg chg="mod">
          <ac:chgData name="Melissa Glasner" userId="1f068961-5534-4ae7-b0aa-012b7ca9fbe6" providerId="ADAL" clId="{2CAF1248-905D-42D0-924E-8B40594556F0}" dt="2025-07-08T16:47:40.797" v="135" actId="1076"/>
          <ac:spMkLst>
            <pc:docMk/>
            <pc:sldMk cId="2752469878" sldId="257"/>
            <ac:spMk id="13" creationId="{E67DB489-C8A2-BB8D-5AAF-C87897EE7E08}"/>
          </ac:spMkLst>
        </pc:spChg>
        <pc:spChg chg="mod">
          <ac:chgData name="Melissa Glasner" userId="1f068961-5534-4ae7-b0aa-012b7ca9fbe6" providerId="ADAL" clId="{2CAF1248-905D-42D0-924E-8B40594556F0}" dt="2025-07-08T16:46:15.437" v="109" actId="1036"/>
          <ac:spMkLst>
            <pc:docMk/>
            <pc:sldMk cId="2752469878" sldId="257"/>
            <ac:spMk id="24" creationId="{0FBBF2DE-D3B0-31DE-59D6-2EA7B086620C}"/>
          </ac:spMkLst>
        </pc:spChg>
        <pc:spChg chg="mod">
          <ac:chgData name="Melissa Glasner" userId="1f068961-5534-4ae7-b0aa-012b7ca9fbe6" providerId="ADAL" clId="{2CAF1248-905D-42D0-924E-8B40594556F0}" dt="2025-07-08T16:46:15.437" v="109" actId="1036"/>
          <ac:spMkLst>
            <pc:docMk/>
            <pc:sldMk cId="2752469878" sldId="257"/>
            <ac:spMk id="25" creationId="{E954B777-8E5E-C4F4-D9F1-454F1AFACB19}"/>
          </ac:spMkLst>
        </pc:spChg>
        <pc:spChg chg="mod">
          <ac:chgData name="Melissa Glasner" userId="1f068961-5534-4ae7-b0aa-012b7ca9fbe6" providerId="ADAL" clId="{2CAF1248-905D-42D0-924E-8B40594556F0}" dt="2025-07-08T16:47:36.390" v="134" actId="1036"/>
          <ac:spMkLst>
            <pc:docMk/>
            <pc:sldMk cId="2752469878" sldId="257"/>
            <ac:spMk id="26" creationId="{E5C77FA8-8205-8BFC-D9A7-FEBF9DEC11F1}"/>
          </ac:spMkLst>
        </pc:spChg>
        <pc:spChg chg="mod">
          <ac:chgData name="Melissa Glasner" userId="1f068961-5534-4ae7-b0aa-012b7ca9fbe6" providerId="ADAL" clId="{2CAF1248-905D-42D0-924E-8B40594556F0}" dt="2025-07-08T16:47:36.390" v="134" actId="1036"/>
          <ac:spMkLst>
            <pc:docMk/>
            <pc:sldMk cId="2752469878" sldId="257"/>
            <ac:spMk id="27" creationId="{B65FF88D-D6C3-586D-227A-7B208767E952}"/>
          </ac:spMkLst>
        </pc:spChg>
        <pc:spChg chg="mod">
          <ac:chgData name="Melissa Glasner" userId="1f068961-5534-4ae7-b0aa-012b7ca9fbe6" providerId="ADAL" clId="{2CAF1248-905D-42D0-924E-8B40594556F0}" dt="2025-07-08T16:46:29.937" v="111" actId="13822"/>
          <ac:spMkLst>
            <pc:docMk/>
            <pc:sldMk cId="2752469878" sldId="257"/>
            <ac:spMk id="28" creationId="{CB90FC4D-6E6F-47C5-004F-5E2B683AE714}"/>
          </ac:spMkLst>
        </pc:spChg>
        <pc:spChg chg="mod">
          <ac:chgData name="Melissa Glasner" userId="1f068961-5534-4ae7-b0aa-012b7ca9fbe6" providerId="ADAL" clId="{2CAF1248-905D-42D0-924E-8B40594556F0}" dt="2025-07-08T16:44:47.710" v="64" actId="113"/>
          <ac:spMkLst>
            <pc:docMk/>
            <pc:sldMk cId="2752469878" sldId="257"/>
            <ac:spMk id="29" creationId="{A3CBCE23-3146-62A8-8172-5182E530378C}"/>
          </ac:spMkLst>
        </pc:spChg>
        <pc:spChg chg="mod">
          <ac:chgData name="Melissa Glasner" userId="1f068961-5534-4ae7-b0aa-012b7ca9fbe6" providerId="ADAL" clId="{2CAF1248-905D-42D0-924E-8B40594556F0}" dt="2025-07-08T16:44:47.710" v="64" actId="113"/>
          <ac:spMkLst>
            <pc:docMk/>
            <pc:sldMk cId="2752469878" sldId="257"/>
            <ac:spMk id="30" creationId="{A56B66E4-B63E-27C3-B265-7BA140C8B930}"/>
          </ac:spMkLst>
        </pc:spChg>
        <pc:picChg chg="add mod">
          <ac:chgData name="Melissa Glasner" userId="1f068961-5534-4ae7-b0aa-012b7ca9fbe6" providerId="ADAL" clId="{2CAF1248-905D-42D0-924E-8B40594556F0}" dt="2025-07-08T16:42:23.598" v="37" actId="1076"/>
          <ac:picMkLst>
            <pc:docMk/>
            <pc:sldMk cId="2752469878" sldId="257"/>
            <ac:picMk id="3" creationId="{BA87248D-2C49-6DA6-1104-C0C63A417A9E}"/>
          </ac:picMkLst>
        </pc:picChg>
        <pc:picChg chg="mod">
          <ac:chgData name="Melissa Glasner" userId="1f068961-5534-4ae7-b0aa-012b7ca9fbe6" providerId="ADAL" clId="{2CAF1248-905D-42D0-924E-8B40594556F0}" dt="2025-07-08T16:47:02.552" v="118" actId="1076"/>
          <ac:picMkLst>
            <pc:docMk/>
            <pc:sldMk cId="2752469878" sldId="257"/>
            <ac:picMk id="10" creationId="{46B81353-EEDC-67B7-5666-08402B3AFFC3}"/>
          </ac:picMkLst>
        </pc:picChg>
        <pc:picChg chg="mod">
          <ac:chgData name="Melissa Glasner" userId="1f068961-5534-4ae7-b0aa-012b7ca9fbe6" providerId="ADAL" clId="{2CAF1248-905D-42D0-924E-8B40594556F0}" dt="2025-07-08T16:46:15.437" v="109" actId="1036"/>
          <ac:picMkLst>
            <pc:docMk/>
            <pc:sldMk cId="2752469878" sldId="257"/>
            <ac:picMk id="19" creationId="{779CD2EC-B35B-43B9-8930-904004B2415C}"/>
          </ac:picMkLst>
        </pc:picChg>
        <pc:picChg chg="mod">
          <ac:chgData name="Melissa Glasner" userId="1f068961-5534-4ae7-b0aa-012b7ca9fbe6" providerId="ADAL" clId="{2CAF1248-905D-42D0-924E-8B40594556F0}" dt="2025-07-08T16:47:36.390" v="134" actId="1036"/>
          <ac:picMkLst>
            <pc:docMk/>
            <pc:sldMk cId="2752469878" sldId="257"/>
            <ac:picMk id="21" creationId="{B9329A2F-9B61-1D23-549E-F40E6AF54C0F}"/>
          </ac:picMkLst>
        </pc:picChg>
        <pc:picChg chg="mod">
          <ac:chgData name="Melissa Glasner" userId="1f068961-5534-4ae7-b0aa-012b7ca9fbe6" providerId="ADAL" clId="{2CAF1248-905D-42D0-924E-8B40594556F0}" dt="2025-07-08T16:47:36.390" v="134" actId="1036"/>
          <ac:picMkLst>
            <pc:docMk/>
            <pc:sldMk cId="2752469878" sldId="257"/>
            <ac:picMk id="23" creationId="{98516BC8-F300-34C4-F38B-A2B916941ADF}"/>
          </ac:picMkLst>
        </pc:picChg>
        <pc:picChg chg="mod">
          <ac:chgData name="Melissa Glasner" userId="1f068961-5534-4ae7-b0aa-012b7ca9fbe6" providerId="ADAL" clId="{2CAF1248-905D-42D0-924E-8B40594556F0}" dt="2025-07-08T16:41:16.932" v="24" actId="408"/>
          <ac:picMkLst>
            <pc:docMk/>
            <pc:sldMk cId="2752469878" sldId="257"/>
            <ac:picMk id="1028" creationId="{59760C50-260D-2632-E5AE-CE2F73C39AEE}"/>
          </ac:picMkLst>
        </pc:picChg>
        <pc:picChg chg="mod">
          <ac:chgData name="Melissa Glasner" userId="1f068961-5534-4ae7-b0aa-012b7ca9fbe6" providerId="ADAL" clId="{2CAF1248-905D-42D0-924E-8B40594556F0}" dt="2025-07-08T16:41:16.932" v="24" actId="408"/>
          <ac:picMkLst>
            <pc:docMk/>
            <pc:sldMk cId="2752469878" sldId="257"/>
            <ac:picMk id="1030" creationId="{7DAD7CDC-DA99-D295-2B0E-088047AA5241}"/>
          </ac:picMkLst>
        </pc:picChg>
        <pc:picChg chg="mod">
          <ac:chgData name="Melissa Glasner" userId="1f068961-5534-4ae7-b0aa-012b7ca9fbe6" providerId="ADAL" clId="{2CAF1248-905D-42D0-924E-8B40594556F0}" dt="2025-07-08T16:46:15.437" v="109" actId="1036"/>
          <ac:picMkLst>
            <pc:docMk/>
            <pc:sldMk cId="2752469878" sldId="257"/>
            <ac:picMk id="1034" creationId="{535BA8F3-57B4-792F-017F-D221E5676AA7}"/>
          </ac:picMkLst>
        </pc:picChg>
        <pc:picChg chg="mod">
          <ac:chgData name="Melissa Glasner" userId="1f068961-5534-4ae7-b0aa-012b7ca9fbe6" providerId="ADAL" clId="{2CAF1248-905D-42D0-924E-8B40594556F0}" dt="2025-07-08T16:44:18.657" v="58" actId="166"/>
          <ac:picMkLst>
            <pc:docMk/>
            <pc:sldMk cId="2752469878" sldId="257"/>
            <ac:picMk id="1036" creationId="{17115A14-1F6E-D591-B60A-8805FABAAD8B}"/>
          </ac:picMkLst>
        </pc:picChg>
        <pc:picChg chg="mod">
          <ac:chgData name="Melissa Glasner" userId="1f068961-5534-4ae7-b0aa-012b7ca9fbe6" providerId="ADAL" clId="{2CAF1248-905D-42D0-924E-8B40594556F0}" dt="2025-07-08T16:43:25.911" v="46" actId="1076"/>
          <ac:picMkLst>
            <pc:docMk/>
            <pc:sldMk cId="2752469878" sldId="257"/>
            <ac:picMk id="1038" creationId="{FDDC4476-3D41-F773-CE77-704860D39FD5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A4A54F3-2682-43B2-87AD-3F53E747ADB5}" type="datetimeFigureOut">
              <a:rPr lang="en-US" smtClean="0"/>
              <a:t>7/31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F5DEDF4-88DB-4F94-8E6F-51D7CF5B0B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82727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F5DEDF4-88DB-4F94-8E6F-51D7CF5B0B8E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253272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087C76-53E8-C7BC-E773-45980C73B1A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86D4419-5EF3-87D0-664D-9ED63F921A2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3B08D76-A5AD-33C3-7D86-4F6978FDB1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B66AE3-1C57-4B74-B7BC-E2702CE9BBB0}" type="datetimeFigureOut">
              <a:rPr lang="en-US" smtClean="0"/>
              <a:t>7/3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9C13FF9-FD80-F56C-6258-C8CC00D88C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C70ADDA-A981-799E-26B4-8FD309203A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AE531D-C470-44A5-8A7C-A96F0330ED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80610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660C693-9E68-4B17-60EE-B417FE05886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208A871-B366-A612-46B2-B3A409BA4A8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7407909-E723-B608-71A0-F30F570085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B66AE3-1C57-4B74-B7BC-E2702CE9BBB0}" type="datetimeFigureOut">
              <a:rPr lang="en-US" smtClean="0"/>
              <a:t>7/3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3E21AC4-433F-41BC-8243-2CD9E8C186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A48EB13-C3F5-DD31-4414-2114C7B8A2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AE531D-C470-44A5-8A7C-A96F0330ED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96073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44914AC-C604-FFF2-12DF-8EBDD5B957D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991CFFE-036F-FB49-C364-8058277C259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721EDF2-206C-C663-826C-0176F47836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B66AE3-1C57-4B74-B7BC-E2702CE9BBB0}" type="datetimeFigureOut">
              <a:rPr lang="en-US" smtClean="0"/>
              <a:t>7/3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ADB95F8-B0AB-8ADB-2AC2-8A0B1EBA63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C6D0583-CF6C-28D7-756E-1F37753FE5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AE531D-C470-44A5-8A7C-A96F0330ED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60123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B71A7D-5474-C409-C0E6-F602A782E9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7ADFF98-09E8-D091-5067-17420C1A0A8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C80A2B7-66A0-EECB-04EE-3992414AB4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B66AE3-1C57-4B74-B7BC-E2702CE9BBB0}" type="datetimeFigureOut">
              <a:rPr lang="en-US" smtClean="0"/>
              <a:t>7/3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CB1993B-7561-0151-0A7D-B42ED16C09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4AEC278-BF84-1B57-2902-E08D50D576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AE531D-C470-44A5-8A7C-A96F0330ED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05724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2D2321-2D30-CD3E-761F-87FBCFCF44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3546EC3-C433-5D7C-6D2E-87FF1608DA9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6A29CE4-F42B-D819-EA75-96BAB3FBAE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B66AE3-1C57-4B74-B7BC-E2702CE9BBB0}" type="datetimeFigureOut">
              <a:rPr lang="en-US" smtClean="0"/>
              <a:t>7/3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2C91E5E-CCD1-506F-4F85-DFB9B2CEAA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7951DE7-7507-6215-0BAB-5AE2C7FE0A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AE531D-C470-44A5-8A7C-A96F0330ED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32647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400D0F-4DBC-95C8-C0A1-BF103A7063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CE7A817-4481-EA22-2B11-9899DC07382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A894431-7851-017E-BF76-F7557969723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4BEC977-FD33-5ECB-888C-8D10494A22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B66AE3-1C57-4B74-B7BC-E2702CE9BBB0}" type="datetimeFigureOut">
              <a:rPr lang="en-US" smtClean="0"/>
              <a:t>7/31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922F5C4-6089-BB89-5334-958EAB1101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BA25297-DDDA-EEE0-D478-4B133B5A84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AE531D-C470-44A5-8A7C-A96F0330ED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87596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2BF49B-AF7A-F0AD-E0E8-0502B07779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0F79A61-2797-A9CE-5FF2-6FC6DE6361B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E960799-9FDE-DBEE-4A14-E4CA72C2D36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C2D5B1E-49CC-2784-AC76-2D7951C70FE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E8EE901-BA56-CC74-2C37-7213679BCC4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D0D7DA3-DB5C-8CB0-6236-E11974C90C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B66AE3-1C57-4B74-B7BC-E2702CE9BBB0}" type="datetimeFigureOut">
              <a:rPr lang="en-US" smtClean="0"/>
              <a:t>7/31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B389F77-461E-BD8B-663F-04A11CB52F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BB63B50-39A3-DAC6-BAEB-E874C22213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AE531D-C470-44A5-8A7C-A96F0330ED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99312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D98F2EA-2407-ABA2-9D61-DF0692F003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C907F28-C727-1574-1878-C67E9E14C4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B66AE3-1C57-4B74-B7BC-E2702CE9BBB0}" type="datetimeFigureOut">
              <a:rPr lang="en-US" smtClean="0"/>
              <a:t>7/31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A3EF88F-AA55-AF8F-E24A-6DECD74B81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BE8A8F8-0F5E-9B6C-69E0-0C9F0A101D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AE531D-C470-44A5-8A7C-A96F0330ED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41765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EFB6FA6-EA72-1AD5-A5B4-2336FFBDB9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B66AE3-1C57-4B74-B7BC-E2702CE9BBB0}" type="datetimeFigureOut">
              <a:rPr lang="en-US" smtClean="0"/>
              <a:t>7/31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251551F-8AAD-3317-BE8B-3FDA6A0936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0412DD8-71FC-F6F3-005C-A366D8FBFF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AE531D-C470-44A5-8A7C-A96F0330ED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81364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022CF81-FCAB-19B6-336F-93D0700E8D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9CBC75E-8273-688F-E59E-FB69D04ED42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755AF14-61E4-DFF1-615D-81F99117E4C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0D661B9-92C6-909B-C90F-0F1110EC27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B66AE3-1C57-4B74-B7BC-E2702CE9BBB0}" type="datetimeFigureOut">
              <a:rPr lang="en-US" smtClean="0"/>
              <a:t>7/31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8B55721-7B31-FDC9-4B9A-1C183B5662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17E2590-15F8-7A31-FE0C-23EE29457F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AE531D-C470-44A5-8A7C-A96F0330ED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64342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8A3A94-7FFB-F4B1-F87B-B8902D22C1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8CC4CF7-AF2C-9DA3-87B4-4C0AC88F21D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9D608E8-44AD-76E6-A89B-EFDD19E81D4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A6A450C-1EC8-22C8-C6FD-67512EAE49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B66AE3-1C57-4B74-B7BC-E2702CE9BBB0}" type="datetimeFigureOut">
              <a:rPr lang="en-US" smtClean="0"/>
              <a:t>7/31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484C3A8-9BD4-88A6-EF9D-C891712F51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7E86D53-999B-D9F7-33B4-2A53A5ED39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AE531D-C470-44A5-8A7C-A96F0330ED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14128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2F4044B-2701-9C54-CD25-9047A67BDE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890797C-7C16-4E42-6359-4EFED408A9D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F25F6FE-C557-C961-B5E1-9716C5C722A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8B66AE3-1C57-4B74-B7BC-E2702CE9BBB0}" type="datetimeFigureOut">
              <a:rPr lang="en-US" smtClean="0"/>
              <a:t>7/3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A69A804-AD88-C90F-F35B-B7EB81A3ED5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946EBB7-860E-0793-F276-E7E5EFC9101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3AE531D-C470-44A5-8A7C-A96F0330ED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91831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svg"/><Relationship Id="rId13" Type="http://schemas.openxmlformats.org/officeDocument/2006/relationships/image" Target="../media/image11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sv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5" Type="http://schemas.openxmlformats.org/officeDocument/2006/relationships/image" Target="../media/image13.svg"/><Relationship Id="rId10" Type="http://schemas.openxmlformats.org/officeDocument/2006/relationships/image" Target="../media/image8.sv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90C88D0A-E0AD-3009-B3F7-996A7F99C013}"/>
              </a:ext>
            </a:extLst>
          </p:cNvPr>
          <p:cNvSpPr txBox="1"/>
          <p:nvPr/>
        </p:nvSpPr>
        <p:spPr>
          <a:xfrm>
            <a:off x="0" y="2615980"/>
            <a:ext cx="12192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Optimizing the Management of </a:t>
            </a:r>
            <a:r>
              <a:rPr lang="en-US" dirty="0" err="1"/>
              <a:t>cTTP</a:t>
            </a:r>
            <a:endParaRPr lang="en-US" dirty="0"/>
          </a:p>
          <a:p>
            <a:pPr algn="ctr"/>
            <a:r>
              <a:rPr lang="en-US" dirty="0"/>
              <a:t>Graphical Abstract  </a:t>
            </a:r>
          </a:p>
        </p:txBody>
      </p:sp>
    </p:spTree>
    <p:extLst>
      <p:ext uri="{BB962C8B-B14F-4D97-AF65-F5344CB8AC3E}">
        <p14:creationId xmlns:p14="http://schemas.microsoft.com/office/powerpoint/2010/main" val="367451532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: Rounded Corners 3">
            <a:extLst>
              <a:ext uri="{FF2B5EF4-FFF2-40B4-BE49-F238E27FC236}">
                <a16:creationId xmlns:a16="http://schemas.microsoft.com/office/drawing/2014/main" id="{D863ACDF-6E65-5476-F731-2EC3AC183BE1}"/>
              </a:ext>
            </a:extLst>
          </p:cNvPr>
          <p:cNvSpPr/>
          <p:nvPr/>
        </p:nvSpPr>
        <p:spPr>
          <a:xfrm>
            <a:off x="838200" y="181648"/>
            <a:ext cx="10608733" cy="1663587"/>
          </a:xfrm>
          <a:prstGeom prst="roundRect">
            <a:avLst/>
          </a:prstGeom>
          <a:noFill/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t" anchorCtr="0"/>
          <a:lstStyle/>
          <a:p>
            <a:pPr algn="ctr"/>
            <a:r>
              <a:rPr lang="en-US" sz="2000" b="1" dirty="0"/>
              <a:t>Mechanism of Disease</a:t>
            </a:r>
          </a:p>
        </p:txBody>
      </p:sp>
      <p:sp>
        <p:nvSpPr>
          <p:cNvPr id="5" name="Rectangle: Rounded Corners 4">
            <a:extLst>
              <a:ext uri="{FF2B5EF4-FFF2-40B4-BE49-F238E27FC236}">
                <a16:creationId xmlns:a16="http://schemas.microsoft.com/office/drawing/2014/main" id="{5FDB41C1-F0CD-4130-6878-D2EF4074BAE7}"/>
              </a:ext>
            </a:extLst>
          </p:cNvPr>
          <p:cNvSpPr/>
          <p:nvPr/>
        </p:nvSpPr>
        <p:spPr>
          <a:xfrm>
            <a:off x="775292" y="1984124"/>
            <a:ext cx="5142018" cy="2016988"/>
          </a:xfrm>
          <a:prstGeom prst="roundRect">
            <a:avLst/>
          </a:prstGeom>
          <a:ln/>
        </p:spPr>
        <p:style>
          <a:lnRef idx="2">
            <a:schemeClr val="accent3"/>
          </a:lnRef>
          <a:fillRef idx="1">
            <a:schemeClr val="lt1"/>
          </a:fillRef>
          <a:effectRef idx="0">
            <a:schemeClr val="accent3"/>
          </a:effectRef>
          <a:fontRef idx="minor">
            <a:schemeClr val="dk1"/>
          </a:fontRef>
        </p:style>
        <p:txBody>
          <a:bodyPr rtlCol="0" anchor="t" anchorCtr="0"/>
          <a:lstStyle/>
          <a:p>
            <a:pPr algn="ctr"/>
            <a:r>
              <a:rPr lang="en-US" b="1" dirty="0">
                <a:solidFill>
                  <a:schemeClr val="tx1"/>
                </a:solidFill>
              </a:rPr>
              <a:t>Trigger Factors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46B81353-EEDC-67B7-5666-08402B3AFFC3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t="18208" b="15865"/>
          <a:stretch/>
        </p:blipFill>
        <p:spPr>
          <a:xfrm>
            <a:off x="2107233" y="733537"/>
            <a:ext cx="7814151" cy="954621"/>
          </a:xfrm>
          <a:prstGeom prst="rect">
            <a:avLst/>
          </a:prstGeom>
        </p:spPr>
      </p:pic>
      <p:pic>
        <p:nvPicPr>
          <p:cNvPr id="1028" name="Picture 4" descr="Pregnancy Icon 6517028">
            <a:extLst>
              <a:ext uri="{FF2B5EF4-FFF2-40B4-BE49-F238E27FC236}">
                <a16:creationId xmlns:a16="http://schemas.microsoft.com/office/drawing/2014/main" id="{59760C50-260D-2632-E5AE-CE2F73C39AE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71247" y="2545362"/>
            <a:ext cx="768861" cy="76886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0" name="Picture 6" descr="Infection Icon 6690667">
            <a:extLst>
              <a:ext uri="{FF2B5EF4-FFF2-40B4-BE49-F238E27FC236}">
                <a16:creationId xmlns:a16="http://schemas.microsoft.com/office/drawing/2014/main" id="{7DAD7CDC-DA99-D295-2B0E-088047AA524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76859" y="2545362"/>
            <a:ext cx="768862" cy="76886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529C8760-3EC7-FE22-C313-D5996586070C}"/>
              </a:ext>
            </a:extLst>
          </p:cNvPr>
          <p:cNvSpPr txBox="1"/>
          <p:nvPr/>
        </p:nvSpPr>
        <p:spPr>
          <a:xfrm>
            <a:off x="1226962" y="3399398"/>
            <a:ext cx="11150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Pregnancy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9832965-B6BA-5212-02D8-9010C937C06B}"/>
              </a:ext>
            </a:extLst>
          </p:cNvPr>
          <p:cNvSpPr txBox="1"/>
          <p:nvPr/>
        </p:nvSpPr>
        <p:spPr>
          <a:xfrm>
            <a:off x="2756037" y="3415788"/>
            <a:ext cx="23236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Infection</a:t>
            </a:r>
          </a:p>
        </p:txBody>
      </p:sp>
      <p:sp>
        <p:nvSpPr>
          <p:cNvPr id="13" name="Rectangle: Rounded Corners 12">
            <a:extLst>
              <a:ext uri="{FF2B5EF4-FFF2-40B4-BE49-F238E27FC236}">
                <a16:creationId xmlns:a16="http://schemas.microsoft.com/office/drawing/2014/main" id="{E67DB489-C8A2-BB8D-5AAF-C87897EE7E08}"/>
              </a:ext>
            </a:extLst>
          </p:cNvPr>
          <p:cNvSpPr/>
          <p:nvPr/>
        </p:nvSpPr>
        <p:spPr>
          <a:xfrm>
            <a:off x="6263854" y="1993210"/>
            <a:ext cx="5142018" cy="4184626"/>
          </a:xfrm>
          <a:prstGeom prst="roundRect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t" anchorCtr="0"/>
          <a:lstStyle/>
          <a:p>
            <a:pPr algn="ctr"/>
            <a:r>
              <a:rPr lang="en-US" b="1" dirty="0"/>
              <a:t>Clinical Manifestations</a:t>
            </a:r>
          </a:p>
        </p:txBody>
      </p:sp>
      <p:pic>
        <p:nvPicPr>
          <p:cNvPr id="1034" name="Picture 10" descr="brain activity Icon 5385203">
            <a:extLst>
              <a:ext uri="{FF2B5EF4-FFF2-40B4-BE49-F238E27FC236}">
                <a16:creationId xmlns:a16="http://schemas.microsoft.com/office/drawing/2014/main" id="{535BA8F3-57B4-792F-017F-D221E5676AA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22053" y="2772555"/>
            <a:ext cx="981899" cy="98189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9" name="Graphic 18" descr="Heart organ with solid fill">
            <a:extLst>
              <a:ext uri="{FF2B5EF4-FFF2-40B4-BE49-F238E27FC236}">
                <a16:creationId xmlns:a16="http://schemas.microsoft.com/office/drawing/2014/main" id="{779CD2EC-B35B-43B9-8930-904004B2415C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96DAC541-7B7A-43D3-8B79-37D633B846F1}">
                <asvg:svgBlip xmlns:asvg="http://schemas.microsoft.com/office/drawing/2016/SVG/main" r:embed="rId8"/>
              </a:ext>
            </a:extLst>
          </a:blip>
          <a:stretch>
            <a:fillRect/>
          </a:stretch>
        </p:blipFill>
        <p:spPr>
          <a:xfrm>
            <a:off x="9485175" y="2718000"/>
            <a:ext cx="1142180" cy="1142180"/>
          </a:xfrm>
          <a:prstGeom prst="rect">
            <a:avLst/>
          </a:prstGeom>
        </p:spPr>
      </p:pic>
      <p:pic>
        <p:nvPicPr>
          <p:cNvPr id="21" name="Graphic 20" descr="Kidneys with solid fill">
            <a:extLst>
              <a:ext uri="{FF2B5EF4-FFF2-40B4-BE49-F238E27FC236}">
                <a16:creationId xmlns:a16="http://schemas.microsoft.com/office/drawing/2014/main" id="{B9329A2F-9B61-1D23-549E-F40E6AF54C0F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96DAC541-7B7A-43D3-8B79-37D633B846F1}">
                <asvg:svgBlip xmlns:asvg="http://schemas.microsoft.com/office/drawing/2016/SVG/main" r:embed="rId10"/>
              </a:ext>
            </a:extLst>
          </a:blip>
          <a:stretch>
            <a:fillRect/>
          </a:stretch>
        </p:blipFill>
        <p:spPr>
          <a:xfrm>
            <a:off x="6959251" y="4411190"/>
            <a:ext cx="1244168" cy="1244168"/>
          </a:xfrm>
          <a:prstGeom prst="rect">
            <a:avLst/>
          </a:prstGeom>
        </p:spPr>
      </p:pic>
      <p:pic>
        <p:nvPicPr>
          <p:cNvPr id="23" name="Graphic 22" descr="Skull outline">
            <a:extLst>
              <a:ext uri="{FF2B5EF4-FFF2-40B4-BE49-F238E27FC236}">
                <a16:creationId xmlns:a16="http://schemas.microsoft.com/office/drawing/2014/main" id="{98516BC8-F300-34C4-F38B-A2B916941ADF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96DAC541-7B7A-43D3-8B79-37D633B846F1}">
                <asvg:svgBlip xmlns:asvg="http://schemas.microsoft.com/office/drawing/2016/SVG/main" r:embed="rId12"/>
              </a:ext>
            </a:extLst>
          </a:blip>
          <a:stretch>
            <a:fillRect/>
          </a:stretch>
        </p:blipFill>
        <p:spPr>
          <a:xfrm>
            <a:off x="9383187" y="4449554"/>
            <a:ext cx="1244168" cy="1244168"/>
          </a:xfrm>
          <a:prstGeom prst="rect">
            <a:avLst/>
          </a:prstGeom>
        </p:spPr>
      </p:pic>
      <p:sp>
        <p:nvSpPr>
          <p:cNvPr id="24" name="TextBox 23">
            <a:extLst>
              <a:ext uri="{FF2B5EF4-FFF2-40B4-BE49-F238E27FC236}">
                <a16:creationId xmlns:a16="http://schemas.microsoft.com/office/drawing/2014/main" id="{0FBBF2DE-D3B0-31DE-59D6-2EA7B086620C}"/>
              </a:ext>
            </a:extLst>
          </p:cNvPr>
          <p:cNvSpPr txBox="1"/>
          <p:nvPr/>
        </p:nvSpPr>
        <p:spPr>
          <a:xfrm>
            <a:off x="6570812" y="3754671"/>
            <a:ext cx="249817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Neurocognitive Impairment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E954B777-8E5E-C4F4-D9F1-454F1AFACB19}"/>
              </a:ext>
            </a:extLst>
          </p:cNvPr>
          <p:cNvSpPr txBox="1"/>
          <p:nvPr/>
        </p:nvSpPr>
        <p:spPr>
          <a:xfrm>
            <a:off x="9068985" y="3760085"/>
            <a:ext cx="215070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Cardiovascular Disease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E5C77FA8-8205-8BFC-D9A7-FEBF9DEC11F1}"/>
              </a:ext>
            </a:extLst>
          </p:cNvPr>
          <p:cNvSpPr txBox="1"/>
          <p:nvPr/>
        </p:nvSpPr>
        <p:spPr>
          <a:xfrm>
            <a:off x="6570812" y="5603408"/>
            <a:ext cx="22274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Chronic Kidney Disease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B65FF88D-D6C3-586D-227A-7B208767E952}"/>
              </a:ext>
            </a:extLst>
          </p:cNvPr>
          <p:cNvSpPr txBox="1"/>
          <p:nvPr/>
        </p:nvSpPr>
        <p:spPr>
          <a:xfrm>
            <a:off x="9067782" y="5603408"/>
            <a:ext cx="19769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Increased Mortality</a:t>
            </a:r>
          </a:p>
        </p:txBody>
      </p:sp>
      <p:sp>
        <p:nvSpPr>
          <p:cNvPr id="28" name="Rectangle: Rounded Corners 27">
            <a:extLst>
              <a:ext uri="{FF2B5EF4-FFF2-40B4-BE49-F238E27FC236}">
                <a16:creationId xmlns:a16="http://schemas.microsoft.com/office/drawing/2014/main" id="{CB90FC4D-6E6F-47C5-004F-5E2B683AE714}"/>
              </a:ext>
            </a:extLst>
          </p:cNvPr>
          <p:cNvSpPr/>
          <p:nvPr/>
        </p:nvSpPr>
        <p:spPr>
          <a:xfrm>
            <a:off x="745887" y="4160848"/>
            <a:ext cx="5142018" cy="2016988"/>
          </a:xfrm>
          <a:prstGeom prst="roundRect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t" anchorCtr="0"/>
          <a:lstStyle/>
          <a:p>
            <a:pPr algn="ctr"/>
            <a:r>
              <a:rPr lang="en-US" b="1" dirty="0"/>
              <a:t>Treatment Approaches</a:t>
            </a:r>
          </a:p>
        </p:txBody>
      </p:sp>
      <p:pic>
        <p:nvPicPr>
          <p:cNvPr id="1038" name="Picture 14" descr="cutting Icon 6014824">
            <a:extLst>
              <a:ext uri="{FF2B5EF4-FFF2-40B4-BE49-F238E27FC236}">
                <a16:creationId xmlns:a16="http://schemas.microsoft.com/office/drawing/2014/main" id="{FDDC4476-3D41-F773-CE77-704860D39FD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5400000">
            <a:off x="3947859" y="4776770"/>
            <a:ext cx="783341" cy="78334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9" name="TextBox 28">
            <a:extLst>
              <a:ext uri="{FF2B5EF4-FFF2-40B4-BE49-F238E27FC236}">
                <a16:creationId xmlns:a16="http://schemas.microsoft.com/office/drawing/2014/main" id="{A3CBCE23-3146-62A8-8172-5182E530378C}"/>
              </a:ext>
            </a:extLst>
          </p:cNvPr>
          <p:cNvSpPr txBox="1"/>
          <p:nvPr/>
        </p:nvSpPr>
        <p:spPr>
          <a:xfrm>
            <a:off x="1371247" y="5654616"/>
            <a:ext cx="20009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Plasma Infusion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A56B66E4-B63E-27C3-B265-7BA140C8B930}"/>
              </a:ext>
            </a:extLst>
          </p:cNvPr>
          <p:cNvSpPr txBox="1"/>
          <p:nvPr/>
        </p:nvSpPr>
        <p:spPr>
          <a:xfrm>
            <a:off x="3161290" y="5654615"/>
            <a:ext cx="23564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Recombinant ADAMTS13</a:t>
            </a:r>
          </a:p>
        </p:txBody>
      </p:sp>
      <p:pic>
        <p:nvPicPr>
          <p:cNvPr id="3" name="Graphic 2" descr="Fire with solid fill">
            <a:extLst>
              <a:ext uri="{FF2B5EF4-FFF2-40B4-BE49-F238E27FC236}">
                <a16:creationId xmlns:a16="http://schemas.microsoft.com/office/drawing/2014/main" id="{BA87248D-2C49-6DA6-1104-C0C63A417A9E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96DAC541-7B7A-43D3-8B79-37D633B846F1}">
                <asvg:svgBlip xmlns:asvg="http://schemas.microsoft.com/office/drawing/2016/SVG/main" r:embed="rId15"/>
              </a:ext>
            </a:extLst>
          </a:blip>
          <a:stretch>
            <a:fillRect/>
          </a:stretch>
        </p:blipFill>
        <p:spPr>
          <a:xfrm>
            <a:off x="4182472" y="2446087"/>
            <a:ext cx="914400" cy="9144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7019A228-BBA8-39DB-7963-ADE231813C7E}"/>
              </a:ext>
            </a:extLst>
          </p:cNvPr>
          <p:cNvSpPr txBox="1"/>
          <p:nvPr/>
        </p:nvSpPr>
        <p:spPr>
          <a:xfrm>
            <a:off x="4092385" y="3429000"/>
            <a:ext cx="23236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Inflammation</a:t>
            </a:r>
          </a:p>
        </p:txBody>
      </p:sp>
      <p:pic>
        <p:nvPicPr>
          <p:cNvPr id="1036" name="Picture 12" descr="blood bag Icon 7050637">
            <a:extLst>
              <a:ext uri="{FF2B5EF4-FFF2-40B4-BE49-F238E27FC236}">
                <a16:creationId xmlns:a16="http://schemas.microsoft.com/office/drawing/2014/main" id="{17115A14-1F6E-D591-B60A-8805FABAAD8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54611" y="4694071"/>
            <a:ext cx="905244" cy="90524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7524698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72221E3A8D84154BBF6AAC13E53147AD" ma:contentTypeVersion="17" ma:contentTypeDescription="Create a new document." ma:contentTypeScope="" ma:versionID="25fa212c587ad1006f52d58642bb7533">
  <xsd:schema xmlns:xsd="http://www.w3.org/2001/XMLSchema" xmlns:xs="http://www.w3.org/2001/XMLSchema" xmlns:p="http://schemas.microsoft.com/office/2006/metadata/properties" xmlns:ns2="20a37e1e-cb09-4705-a5f2-a49cbb19fca6" xmlns:ns3="1ee2e583-4fe5-4f06-8855-a62d82653687" targetNamespace="http://schemas.microsoft.com/office/2006/metadata/properties" ma:root="true" ma:fieldsID="cfca0c6527dbd99b8a3e7581e3413c31" ns2:_="" ns3:_="">
    <xsd:import namespace="20a37e1e-cb09-4705-a5f2-a49cbb19fca6"/>
    <xsd:import namespace="1ee2e583-4fe5-4f06-8855-a62d82653687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SearchProperties" minOccurs="0"/>
                <xsd:element ref="ns2:MediaServiceObjectDetectorVersions" minOccurs="0"/>
                <xsd:element ref="ns2:MediaLengthInSeconds" minOccurs="0"/>
                <xsd:element ref="ns3:SharedWithUsers" minOccurs="0"/>
                <xsd:element ref="ns3:SharedWithDetails" minOccurs="0"/>
                <xsd:element ref="ns2:MediaServiceDateTaken" minOccurs="0"/>
                <xsd:element ref="ns2:MediaServiceGenerationTime" minOccurs="0"/>
                <xsd:element ref="ns2:MediaServiceEventHashCode" minOccurs="0"/>
                <xsd:element ref="ns2:lcf76f155ced4ddcb4097134ff3c332f" minOccurs="0"/>
                <xsd:element ref="ns3:TaxCatchAll" minOccurs="0"/>
                <xsd:element ref="ns2:MediaServiceOCR" minOccurs="0"/>
                <xsd:element ref="ns2:MediaServiceLocation" minOccurs="0"/>
                <xsd:element ref="ns2:MediaServiceBillingMetadata" minOccurs="0"/>
                <xsd:element ref="ns2:Docstatu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20a37e1e-cb09-4705-a5f2-a49cbb19fca6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SearchProperties" ma:index="10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ObjectDetectorVersions" ma:index="11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LengthInSeconds" ma:index="12" nillable="true" ma:displayName="MediaLengthInSeconds" ma:hidden="true" ma:internalName="MediaLengthInSeconds" ma:readOnly="true">
      <xsd:simpleType>
        <xsd:restriction base="dms:Unknown"/>
      </xsd:simpleType>
    </xsd:element>
    <xsd:element name="MediaServiceDateTaken" ma:index="15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GenerationTime" ma:index="16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lcf76f155ced4ddcb4097134ff3c332f" ma:index="19" nillable="true" ma:taxonomy="true" ma:internalName="lcf76f155ced4ddcb4097134ff3c332f" ma:taxonomyFieldName="MediaServiceImageTags" ma:displayName="Image Tags" ma:readOnly="false" ma:fieldId="{5cf76f15-5ced-4ddc-b409-7134ff3c332f}" ma:taxonomyMulti="true" ma:sspId="7f99c727-3acf-4c25-8995-31529a254356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CR" ma:index="21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Location" ma:index="22" nillable="true" ma:displayName="Location" ma:indexed="true" ma:internalName="MediaServiceLocation" ma:readOnly="true">
      <xsd:simpleType>
        <xsd:restriction base="dms:Text"/>
      </xsd:simpleType>
    </xsd:element>
    <xsd:element name="MediaServiceBillingMetadata" ma:index="23" nillable="true" ma:displayName="MediaServiceBillingMetadata" ma:hidden="true" ma:internalName="MediaServiceBillingMetadata" ma:readOnly="true">
      <xsd:simpleType>
        <xsd:restriction base="dms:Note"/>
      </xsd:simpleType>
    </xsd:element>
    <xsd:element name="Docstatus" ma:index="24" nillable="true" ma:displayName="Doc status" ma:format="Dropdown" ma:internalName="Docstatus">
      <xsd:simpleType>
        <xsd:restriction base="dms:Text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ee2e583-4fe5-4f06-8855-a62d82653687" elementFormDefault="qualified">
    <xsd:import namespace="http://schemas.microsoft.com/office/2006/documentManagement/types"/>
    <xsd:import namespace="http://schemas.microsoft.com/office/infopath/2007/PartnerControls"/>
    <xsd:element name="SharedWithUsers" ma:index="13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4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20" nillable="true" ma:displayName="Taxonomy Catch All Column" ma:hidden="true" ma:list="{304f8d5b-246d-4e13-bb4b-da016b0bb1a3}" ma:internalName="TaxCatchAll" ma:showField="CatchAllData" ma:web="1ee2e583-4fe5-4f06-8855-a62d82653687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20a37e1e-cb09-4705-a5f2-a49cbb19fca6">
      <Terms xmlns="http://schemas.microsoft.com/office/infopath/2007/PartnerControls"/>
    </lcf76f155ced4ddcb4097134ff3c332f>
    <TaxCatchAll xmlns="1ee2e583-4fe5-4f06-8855-a62d82653687" xsi:nil="true"/>
    <Docstatus xmlns="20a37e1e-cb09-4705-a5f2-a49cbb19fca6" xsi:nil="true"/>
  </documentManagement>
</p:properties>
</file>

<file path=customXml/itemProps1.xml><?xml version="1.0" encoding="utf-8"?>
<ds:datastoreItem xmlns:ds="http://schemas.openxmlformats.org/officeDocument/2006/customXml" ds:itemID="{B5BECFCB-94D3-4F30-B129-ED74995E8671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20a37e1e-cb09-4705-a5f2-a49cbb19fca6"/>
    <ds:schemaRef ds:uri="1ee2e583-4fe5-4f06-8855-a62d82653687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E9BB52A6-7EAE-4595-8FA5-E0C609EDADFB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A704F7D2-04BA-4EA4-A741-CB1A47472FF1}">
  <ds:schemaRefs>
    <ds:schemaRef ds:uri="http://schemas.microsoft.com/office/2006/metadata/properties"/>
    <ds:schemaRef ds:uri="http://purl.org/dc/terms/"/>
    <ds:schemaRef ds:uri="http://schemas.microsoft.com/office/infopath/2007/PartnerControls"/>
    <ds:schemaRef ds:uri="http://www.w3.org/XML/1998/namespace"/>
    <ds:schemaRef ds:uri="http://schemas.openxmlformats.org/package/2006/metadata/core-properties"/>
    <ds:schemaRef ds:uri="http://schemas.microsoft.com/office/2006/documentManagement/types"/>
    <ds:schemaRef ds:uri="http://purl.org/dc/elements/1.1/"/>
    <ds:schemaRef ds:uri="1ee2e583-4fe5-4f06-8855-a62d82653687"/>
    <ds:schemaRef ds:uri="20a37e1e-cb09-4705-a5f2-a49cbb19fca6"/>
    <ds:schemaRef ds:uri="http://purl.org/dc/dcmitype/"/>
  </ds:schemaRefs>
</ds:datastoreItem>
</file>

<file path=docMetadata/LabelInfo.xml><?xml version="1.0" encoding="utf-8"?>
<clbl:labelList xmlns:clbl="http://schemas.microsoft.com/office/2020/mipLabelMetadata">
  <clbl:label id="{216d5ee7-4f7f-4833-b132-58e01d11e902}" enabled="0" method="" siteId="{216d5ee7-4f7f-4833-b132-58e01d11e902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103</TotalTime>
  <Words>33</Words>
  <Application>Microsoft Office PowerPoint</Application>
  <PresentationFormat>Widescreen</PresentationFormat>
  <Paragraphs>16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ptos</vt:lpstr>
      <vt:lpstr>Aptos Display</vt:lpstr>
      <vt:lpstr>Arial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elissa Glasner</dc:creator>
  <cp:lastModifiedBy>Miriam Giles</cp:lastModifiedBy>
  <cp:revision>3</cp:revision>
  <dcterms:created xsi:type="dcterms:W3CDTF">2024-12-18T14:04:36Z</dcterms:created>
  <dcterms:modified xsi:type="dcterms:W3CDTF">2025-07-31T17:12:4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72221E3A8D84154BBF6AAC13E53147AD</vt:lpwstr>
  </property>
  <property fmtid="{D5CDD505-2E9C-101B-9397-08002B2CF9AE}" pid="3" name="MediaServiceImageTags">
    <vt:lpwstr/>
  </property>
</Properties>
</file>